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70" y="-3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9575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2712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30455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65072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1390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543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9425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0040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71354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122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929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545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1" name="Group 230"/>
          <p:cNvGrpSpPr/>
          <p:nvPr/>
        </p:nvGrpSpPr>
        <p:grpSpPr>
          <a:xfrm>
            <a:off x="476673" y="534906"/>
            <a:ext cx="6048672" cy="4582718"/>
            <a:chOff x="476673" y="534906"/>
            <a:chExt cx="6048672" cy="4582718"/>
          </a:xfrm>
        </p:grpSpPr>
        <p:sp>
          <p:nvSpPr>
            <p:cNvPr id="232" name="TextBox 231"/>
            <p:cNvSpPr txBox="1"/>
            <p:nvPr/>
          </p:nvSpPr>
          <p:spPr>
            <a:xfrm>
              <a:off x="476673" y="534906"/>
              <a:ext cx="60486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200" dirty="0" smtClean="0"/>
                <a:t>Supplemental Figure 1. Expression of endothelial tight junction and </a:t>
              </a:r>
              <a:r>
                <a:rPr lang="en-NZ" sz="1200" dirty="0" smtClean="0"/>
                <a:t>adherens </a:t>
              </a:r>
              <a:r>
                <a:rPr lang="en-NZ" sz="1200" dirty="0" smtClean="0"/>
                <a:t>junction proteins by </a:t>
              </a:r>
              <a:r>
                <a:rPr lang="en-NZ" sz="1200" dirty="0" err="1" smtClean="0"/>
                <a:t>hCMVECs</a:t>
              </a:r>
              <a:endParaRPr lang="en-NZ" sz="1200" dirty="0"/>
            </a:p>
          </p:txBody>
        </p:sp>
        <p:pic>
          <p:nvPicPr>
            <p:cNvPr id="233" name="Picture 2" descr="F:\experimental work\ICC\ICC 10- Confocal ZO-1 and VE-cad images\VE-cad tif\VE-cad (3) zoomed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1902" y="1572028"/>
              <a:ext cx="1816100" cy="10464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4" name="TextBox 233"/>
            <p:cNvSpPr txBox="1"/>
            <p:nvPr/>
          </p:nvSpPr>
          <p:spPr>
            <a:xfrm>
              <a:off x="1637906" y="1306669"/>
              <a:ext cx="1791094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NZ" sz="1200" dirty="0" smtClean="0"/>
                <a:t>VE-Cadherin (CD144)</a:t>
              </a:r>
              <a:endParaRPr lang="en-NZ" sz="1200" dirty="0"/>
            </a:p>
          </p:txBody>
        </p:sp>
        <p:pic>
          <p:nvPicPr>
            <p:cNvPr id="235" name="Picture 3" descr="F:\experimental work\ICC\ICC 10- Confocal ZO-1 and VE-cad images\ZO-1 tif\zo-1_60xobjec._merge1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409" b="1"/>
            <a:stretch/>
          </p:blipFill>
          <p:spPr bwMode="auto">
            <a:xfrm>
              <a:off x="1476979" y="3683133"/>
              <a:ext cx="1950720" cy="10649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6" name="TextBox 235"/>
            <p:cNvSpPr txBox="1"/>
            <p:nvPr/>
          </p:nvSpPr>
          <p:spPr>
            <a:xfrm>
              <a:off x="1905009" y="3393742"/>
              <a:ext cx="1311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NZ" sz="1200" dirty="0" smtClean="0"/>
                <a:t>Zonula Occludin-1</a:t>
              </a:r>
              <a:endParaRPr lang="en-NZ" sz="1200" dirty="0"/>
            </a:p>
          </p:txBody>
        </p:sp>
        <p:sp>
          <p:nvSpPr>
            <p:cNvPr id="237" name="Rectangle 236"/>
            <p:cNvSpPr/>
            <p:nvPr/>
          </p:nvSpPr>
          <p:spPr>
            <a:xfrm>
              <a:off x="1997946" y="1716044"/>
              <a:ext cx="579316" cy="612068"/>
            </a:xfrm>
            <a:prstGeom prst="rect">
              <a:avLst/>
            </a:prstGeom>
            <a:noFill/>
            <a:ln w="31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pic>
          <p:nvPicPr>
            <p:cNvPr id="238" name="Picture 2" descr="F:\experimental work\ICC\ICC 10- Confocal ZO-1 and VE-cad images\VE-cad tif\VE-cad (3) zoomed.t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55" t="13762" r="45667" b="27750"/>
            <a:stretch/>
          </p:blipFill>
          <p:spPr bwMode="auto">
            <a:xfrm>
              <a:off x="3547674" y="1418857"/>
              <a:ext cx="1465502" cy="15301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39" name="Straight Arrow Connector 238"/>
            <p:cNvCxnSpPr/>
            <p:nvPr/>
          </p:nvCxnSpPr>
          <p:spPr>
            <a:xfrm>
              <a:off x="4293096" y="2012916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Arrow Connector 239"/>
            <p:cNvCxnSpPr/>
            <p:nvPr/>
          </p:nvCxnSpPr>
          <p:spPr>
            <a:xfrm>
              <a:off x="4190415" y="2681354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Arrow Connector 240"/>
            <p:cNvCxnSpPr/>
            <p:nvPr/>
          </p:nvCxnSpPr>
          <p:spPr>
            <a:xfrm>
              <a:off x="4278613" y="2228783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Arrow Connector 241"/>
            <p:cNvCxnSpPr/>
            <p:nvPr/>
          </p:nvCxnSpPr>
          <p:spPr>
            <a:xfrm>
              <a:off x="4265476" y="2480968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Arrow Connector 242"/>
            <p:cNvCxnSpPr/>
            <p:nvPr/>
          </p:nvCxnSpPr>
          <p:spPr>
            <a:xfrm>
              <a:off x="4175466" y="1778890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Rectangle 243"/>
            <p:cNvSpPr/>
            <p:nvPr/>
          </p:nvSpPr>
          <p:spPr>
            <a:xfrm>
              <a:off x="2485091" y="4117819"/>
              <a:ext cx="579316" cy="612068"/>
            </a:xfrm>
            <a:prstGeom prst="rect">
              <a:avLst/>
            </a:prstGeom>
            <a:noFill/>
            <a:ln w="31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pic>
          <p:nvPicPr>
            <p:cNvPr id="245" name="Picture 3" descr="F:\experimental work\ICC\ICC 10- Confocal ZO-1 and VE-cad images\ZO-1 tif\zo-1_60xobjec._merge1.tif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16" t="67402" r="17960"/>
            <a:stretch/>
          </p:blipFill>
          <p:spPr bwMode="auto">
            <a:xfrm>
              <a:off x="3519705" y="3527884"/>
              <a:ext cx="1493471" cy="1589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46" name="Straight Arrow Connector 245"/>
            <p:cNvCxnSpPr/>
            <p:nvPr/>
          </p:nvCxnSpPr>
          <p:spPr>
            <a:xfrm>
              <a:off x="4161482" y="4896036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Arrow Connector 246"/>
            <p:cNvCxnSpPr/>
            <p:nvPr/>
          </p:nvCxnSpPr>
          <p:spPr>
            <a:xfrm>
              <a:off x="4585146" y="4417800"/>
              <a:ext cx="180020" cy="3600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Arrow Connector 247"/>
            <p:cNvCxnSpPr/>
            <p:nvPr/>
          </p:nvCxnSpPr>
          <p:spPr>
            <a:xfrm flipH="1" flipV="1">
              <a:off x="4801170" y="4544854"/>
              <a:ext cx="145275" cy="33965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Straight Arrow Connector 248"/>
            <p:cNvCxnSpPr/>
            <p:nvPr/>
          </p:nvCxnSpPr>
          <p:spPr>
            <a:xfrm flipH="1" flipV="1">
              <a:off x="4728532" y="4731055"/>
              <a:ext cx="145275" cy="33965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Straight Arrow Connector 249"/>
            <p:cNvCxnSpPr/>
            <p:nvPr/>
          </p:nvCxnSpPr>
          <p:spPr>
            <a:xfrm flipH="1" flipV="1">
              <a:off x="4580466" y="4913874"/>
              <a:ext cx="145275" cy="33965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40870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6</cp:revision>
  <dcterms:created xsi:type="dcterms:W3CDTF">2014-12-21T23:06:00Z</dcterms:created>
  <dcterms:modified xsi:type="dcterms:W3CDTF">2014-12-21T23:10:29Z</dcterms:modified>
</cp:coreProperties>
</file>